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17280" y="744120"/>
            <a:ext cx="496260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600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DFA8405-9166-4672-B508-E4DD8DE294D3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53" name="PlaceHolder 2"/>
          <p:cNvSpPr>
            <a:spLocks noGrp="1"/>
          </p:cNvSpPr>
          <p:nvPr>
            <p:ph type="body"/>
          </p:nvPr>
        </p:nvSpPr>
        <p:spPr>
          <a:xfrm>
            <a:off x="679320" y="471600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Additional Figure 3:  Hazard ratios of joint ER+PR+ and ER-PR- tumors for increased waist circumference across 5-year age-bands.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ll models are for a 5 kg/m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increase in BMI and were stratified by age at recruitment and study center. Hazard ratio estimates are shown for all women and HRT never user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Slide Number Placeholder 3"/>
          <p:cNvSpPr/>
          <p:nvPr/>
        </p:nvSpPr>
        <p:spPr>
          <a:xfrm>
            <a:off x="384984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7EB4238-C3C9-4333-8934-0221BF683FBA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A25ACF-4A5A-4044-9C99-CC9C567A573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ECF10B-F900-4E32-9173-FBF0B5B751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AF4DBB-F842-47F1-A1AA-2755F8ADE67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D58B0E-9AE2-43DA-885D-755780974E7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E5BE94-7EF7-49C0-BCC3-749A523AB7C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0FAB6E-6523-477E-863D-CC1751C9AE7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7D59EF-DC22-45A9-9DA2-328A9187AAF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B134CB-8042-46B2-A2F4-80E2FD46A90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166B85-B240-41C5-9197-FD76C00547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70F22B-EFC6-4013-9029-0EAF27A7C4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8CDB06-AB11-4555-B273-FCF5A190C1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D80A85-E0F0-45DA-BE61-E865F7E37E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72FCE5C-FBA2-41D5-914D-EC27BC5F850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5"/>
          <p:cNvSpPr/>
          <p:nvPr/>
        </p:nvSpPr>
        <p:spPr>
          <a:xfrm>
            <a:off x="144360" y="1674720"/>
            <a:ext cx="8926560" cy="34419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2"/>
          <p:cNvSpPr/>
          <p:nvPr/>
        </p:nvSpPr>
        <p:spPr>
          <a:xfrm>
            <a:off x="345960" y="4621320"/>
            <a:ext cx="84470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Figure s3 Hazard ratios of joint ER+PR+ and ER-PR- tumors for increased waist circumference across 5-year age-bands.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All models are for a 5 kg/m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increase in BMI and were stratified by age at recruitment and study center. Hazard ratio estimates are shown for all women and HRT never users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" name="Chart 7" descr=""/>
          <p:cNvPicPr/>
          <p:nvPr/>
        </p:nvPicPr>
        <p:blipFill>
          <a:blip r:embed="rId1"/>
          <a:stretch/>
        </p:blipFill>
        <p:spPr>
          <a:xfrm>
            <a:off x="268200" y="1889280"/>
            <a:ext cx="4986360" cy="2755800"/>
          </a:xfrm>
          <a:prstGeom prst="rect">
            <a:avLst/>
          </a:prstGeom>
          <a:ln w="0">
            <a:noFill/>
          </a:ln>
        </p:spPr>
      </p:pic>
      <p:pic>
        <p:nvPicPr>
          <p:cNvPr id="51" name="Chart 8" descr=""/>
          <p:cNvPicPr/>
          <p:nvPr/>
        </p:nvPicPr>
        <p:blipFill>
          <a:blip r:embed="rId2"/>
          <a:stretch/>
        </p:blipFill>
        <p:spPr>
          <a:xfrm>
            <a:off x="3981600" y="1895400"/>
            <a:ext cx="5016240" cy="2768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2-08T11:43:57Z</dcterms:created>
  <dc:creator>James, Rebecca</dc:creator>
  <dc:description/>
  <dc:language>en-US</dc:language>
  <cp:lastModifiedBy>Rebecca Ritte</cp:lastModifiedBy>
  <cp:lastPrinted>2011-12-13T11:51:43Z</cp:lastPrinted>
  <dcterms:modified xsi:type="dcterms:W3CDTF">2012-05-10T09:11:20Z</dcterms:modified>
  <cp:revision>47</cp:revision>
  <dc:subject/>
  <dc:title>PowerPoint Presentation</dc:title>
</cp:coreProperties>
</file>